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5" y="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E39AE4-17F0-48CE-8DF0-DB9FC1CF051A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42EE1E-F8E4-4290-ACFD-ECE62C6F6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385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97013" y="1200150"/>
            <a:ext cx="4321175" cy="3240088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</a:t>
            </a:r>
            <a:r>
              <a:rPr lang="en-US" baseline="0" dirty="0"/>
              <a:t> 1. Of course, need to update it to have photos of cortical pie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872F96-EA7C-4941-A4E1-204FA6C31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6446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51B365-D274-4EFA-B680-CF55EBB761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BDD973-74A7-447A-BE08-92D92FE049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2F0302-BB32-4BA4-9C01-94170BD59C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1A917-B093-4A15-9939-767E156631EB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6B86B2-2308-474E-ADB3-CC0AB066F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578699-A812-4636-80C2-48BB55C3F8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DE0BB4-0F45-4166-9A7E-01A7E6FB1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316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4EEB4D-D4B4-48F4-AE2A-8AA4BF4B59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974125-26D9-48EE-AE16-A73481EE4F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97572D-6D20-483B-85CE-4B275B2194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1A917-B093-4A15-9939-767E156631EB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3E218E-6E30-48A4-B485-3F37321EE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A15C20-CB81-4009-B691-57981C9AB4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DE0BB4-0F45-4166-9A7E-01A7E6FB1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139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3094324-BCC0-472E-A91B-93CBB8C20D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B0D17-47DD-4653-B8E2-84D9F6BD20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BF3F74-3C6C-49E3-A436-A71A034A7B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1A917-B093-4A15-9939-767E156631EB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A81FFA-94A1-4CEB-93B8-405FE157A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5BE606-0708-42FD-A135-828CB908B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DE0BB4-0F45-4166-9A7E-01A7E6FB1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207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CA2211-7A5A-4173-9494-69F2EB620F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318315-78F3-495B-B30A-CF3CEC1CA3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BC0F54-EF39-48A8-A296-19578B87E9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1A917-B093-4A15-9939-767E156631EB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B37792-B20E-4DE0-A393-A75EE24AF5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9F1735-5183-4E84-B0D5-80CD022C3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DE0BB4-0F45-4166-9A7E-01A7E6FB1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033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2E1447-8683-4441-88F5-92F28B98E0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9E5287-E071-4273-A8C9-C55CF5384E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682FF2-B35C-42E9-A95C-E5180602C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1A917-B093-4A15-9939-767E156631EB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093B2C-0A01-4ADD-B734-89EB965006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4E3B21-D72C-4ED4-B43B-4D44DD1405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DE0BB4-0F45-4166-9A7E-01A7E6FB1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877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ED6ECA-BD19-40E1-A2EB-5F05F9A191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0C1102-9AC7-46AD-80F1-3744CF5D2A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603AE9-E045-433E-B4E5-5F6111AB2E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7B1517-FAB1-40C4-B317-FF231592F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1A917-B093-4A15-9939-767E156631EB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9AEBC-1395-490F-A823-94EA3E54A9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0118B4-2428-4645-A8CA-093CC68B9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DE0BB4-0F45-4166-9A7E-01A7E6FB1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3998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397FD7-616B-4EE5-AA19-D197B1F6F6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5555D7-9F67-4E58-9786-C732F8F5DE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3EAC02-4764-47E5-B87D-DF330DB972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AF8073-E266-4A9A-965F-5C57EEBEDD8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932CD23-720D-4C18-B4A7-B9CAC8790A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1EEB0AC-2D73-4ECE-9192-6EB5AAACA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1A917-B093-4A15-9939-767E156631EB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45E4891-E8E2-4A3B-94A3-43E7A6FDC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434ADD4-5B42-42CB-9C33-C03F0762D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DE0BB4-0F45-4166-9A7E-01A7E6FB1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482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E4CDEF-52C2-4160-8919-BBBE6C82E2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B449338-D698-4F77-BBB5-99FAB8197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1A917-B093-4A15-9939-767E156631EB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87D5F28-351C-41CC-B3F0-D6595053CB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9F88C4D-1844-4A01-80AD-E0B02E393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DE0BB4-0F45-4166-9A7E-01A7E6FB1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627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4BF995B-7BA2-4243-8E11-FDE63D4E7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1A917-B093-4A15-9939-767E156631EB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67845C-039F-4557-9759-AA0EF29FA9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AFD45F7-795A-432E-8F10-5E17211D2F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DE0BB4-0F45-4166-9A7E-01A7E6FB1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730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A64266-A970-42EA-9E00-05CC1887CE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4701C4-B37F-4DD4-94D6-160D5B2369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596507-FA6A-4B46-ADA0-ED616288F3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79DA5B-0892-4652-946E-D986E46AC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1A917-B093-4A15-9939-767E156631EB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56D9BB-60D5-43DC-AAB8-FC02B119A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7E7B6D-17C5-4D24-ADE7-D8E917E153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DE0BB4-0F45-4166-9A7E-01A7E6FB1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634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F8C0CB-E83C-4E58-B4BE-ECD2475EDA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9A5C3E9-D84F-4D3C-874E-C651719C76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0BDDC7-C036-4417-8201-D6202DAB2D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635985-5771-4607-B0FF-E4CE8F54D3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1A917-B093-4A15-9939-767E156631EB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17834F-D9CF-49DA-B354-8AB6C20B5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934BEC-CB26-4FC9-967D-22F3EAF25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DE0BB4-0F45-4166-9A7E-01A7E6FB1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648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0D4059B-AEA6-4E5A-ADFF-4F3E80F731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09D892-AD74-497F-8F44-F29A3380BE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4BE146-C41F-463F-80CD-200BEDC671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E1A917-B093-4A15-9939-767E156631EB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22FBAF-A0C5-4454-9321-9BD0CA4188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6AAA82-55DA-4717-9BC1-DC64FEA987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DE0BB4-0F45-4166-9A7E-01A7E6FB10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745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10" Type="http://schemas.openxmlformats.org/officeDocument/2006/relationships/image" Target="../media/image8.tiff"/><Relationship Id="rId4" Type="http://schemas.openxmlformats.org/officeDocument/2006/relationships/image" Target="../media/image2.jpeg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e 11"/>
          <p:cNvGraphicFramePr>
            <a:graphicFrameLocks noGrp="1"/>
          </p:cNvGraphicFramePr>
          <p:nvPr/>
        </p:nvGraphicFramePr>
        <p:xfrm>
          <a:off x="3036503" y="703250"/>
          <a:ext cx="5461611" cy="474475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461611">
                  <a:extLst>
                    <a:ext uri="{9D8B030D-6E8A-4147-A177-3AD203B41FA5}">
                      <a16:colId xmlns:a16="http://schemas.microsoft.com/office/drawing/2014/main" val="2891490085"/>
                    </a:ext>
                  </a:extLst>
                </a:gridCol>
              </a:tblGrid>
              <a:tr h="4026559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/>
                          <a:cs typeface="Arial"/>
                        </a:rPr>
                        <a:t>Murine surgery </a:t>
                      </a: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7681369"/>
                  </a:ext>
                </a:extLst>
              </a:tr>
              <a:tr h="718197">
                <a:tc>
                  <a:txBody>
                    <a:bodyPr/>
                    <a:lstStyle/>
                    <a:p>
                      <a:r>
                        <a:rPr lang="en-US" sz="800" b="0" dirty="0">
                          <a:latin typeface="Arial"/>
                          <a:cs typeface="Arial"/>
                        </a:rPr>
                        <a:t>Supplemental Figure 1. Murine surgery. </a:t>
                      </a:r>
                      <a:r>
                        <a:rPr lang="en-US" sz="800" b="0" dirty="0">
                          <a:latin typeface="Arial"/>
                          <a:ea typeface="Calibri" panose="020F0502020204030204" pitchFamily="34" charset="0"/>
                          <a:cs typeface="Arial"/>
                        </a:rPr>
                        <a:t>(</a:t>
                      </a:r>
                      <a:r>
                        <a:rPr lang="en-US" sz="800" b="0" dirty="0">
                          <a:solidFill>
                            <a:srgbClr val="000000"/>
                          </a:solidFill>
                          <a:latin typeface="Arial"/>
                          <a:ea typeface="Calibri" panose="020F0502020204030204" pitchFamily="34" charset="0"/>
                          <a:cs typeface="Arial"/>
                        </a:rPr>
                        <a:t>a) Skin incision; (b) Subcutaneous dissection; (c) Insertion of cortical allograft; (d) Inoculation with </a:t>
                      </a:r>
                      <a:r>
                        <a:rPr lang="en-US" sz="800" b="0" i="1" dirty="0">
                          <a:solidFill>
                            <a:srgbClr val="000000"/>
                          </a:solidFill>
                          <a:latin typeface="Arial"/>
                          <a:ea typeface="Calibri" panose="020F0502020204030204" pitchFamily="34" charset="0"/>
                          <a:cs typeface="Arial"/>
                        </a:rPr>
                        <a:t>S. </a:t>
                      </a:r>
                      <a:r>
                        <a:rPr lang="en-US" sz="800" b="0" i="1" dirty="0" err="1">
                          <a:solidFill>
                            <a:srgbClr val="000000"/>
                          </a:solidFill>
                          <a:latin typeface="Arial"/>
                          <a:ea typeface="Calibri" panose="020F0502020204030204" pitchFamily="34" charset="0"/>
                          <a:cs typeface="Arial"/>
                        </a:rPr>
                        <a:t>aurefus</a:t>
                      </a:r>
                      <a:r>
                        <a:rPr lang="en-US" sz="800" b="0" dirty="0">
                          <a:solidFill>
                            <a:srgbClr val="000000"/>
                          </a:solidFill>
                          <a:latin typeface="Arial"/>
                          <a:ea typeface="Calibri" panose="020F0502020204030204" pitchFamily="34" charset="0"/>
                          <a:cs typeface="Arial"/>
                        </a:rPr>
                        <a:t>; (e) Closure of the surgical site; (f) Post-surgical</a:t>
                      </a:r>
                      <a:r>
                        <a:rPr lang="en-US" sz="800" b="0" baseline="0" dirty="0">
                          <a:solidFill>
                            <a:srgbClr val="000000"/>
                          </a:solidFill>
                          <a:latin typeface="Arial"/>
                          <a:ea typeface="Calibri" panose="020F0502020204030204" pitchFamily="34" charset="0"/>
                          <a:cs typeface="Arial"/>
                        </a:rPr>
                        <a:t> radiograph of cortical allograft; (g) Post-surgical radiograph of stainless steel; (h) Post-surgical radiograph of cancellous allograft.</a:t>
                      </a:r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04944133"/>
                  </a:ext>
                </a:extLst>
              </a:tr>
            </a:tbl>
          </a:graphicData>
        </a:graphic>
      </p:graphicFrame>
      <p:sp>
        <p:nvSpPr>
          <p:cNvPr id="26" name="Rectangle 25">
            <a:extLst>
              <a:ext uri="{FF2B5EF4-FFF2-40B4-BE49-F238E27FC236}">
                <a16:creationId xmlns:a16="http://schemas.microsoft.com/office/drawing/2014/main" id="{D9B1D5FB-DC21-4386-93D1-FF3B8D4EBFFB}"/>
              </a:ext>
            </a:extLst>
          </p:cNvPr>
          <p:cNvSpPr/>
          <p:nvPr/>
        </p:nvSpPr>
        <p:spPr>
          <a:xfrm>
            <a:off x="3036503" y="995399"/>
            <a:ext cx="5461610" cy="37270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F00D1E22-AE86-49BF-8D20-DAB0B3B667D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27" t="26389" r="4493"/>
          <a:stretch/>
        </p:blipFill>
        <p:spPr>
          <a:xfrm>
            <a:off x="6687918" y="3201361"/>
            <a:ext cx="564315" cy="1102589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3F0261A5-5181-4604-852B-24FBBFE0BB3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07527" y="1081559"/>
            <a:ext cx="1711980" cy="1710449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7BB03786-AAF4-49C3-8642-425CA60654A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13972" y="1083108"/>
            <a:ext cx="1710729" cy="1709198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22930C4C-E868-4372-A6F7-0AA94426901F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721865" y="1081560"/>
            <a:ext cx="1623107" cy="1710449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58FF3C36-D03E-413C-B4B3-2DFBD1415DD6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03174" y="2870505"/>
            <a:ext cx="1719346" cy="1747855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945D1FF3-31D7-41A4-A317-26A76486B8CC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14543" y="2876930"/>
            <a:ext cx="1710156" cy="1749216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62B58E06-C3DD-45C7-981C-648CBCD60F4C}"/>
              </a:ext>
            </a:extLst>
          </p:cNvPr>
          <p:cNvSpPr txBox="1"/>
          <p:nvPr/>
        </p:nvSpPr>
        <p:spPr>
          <a:xfrm>
            <a:off x="4541890" y="2576563"/>
            <a:ext cx="6643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0318804-3C98-4FFB-8B5A-14A2219EEB63}"/>
              </a:ext>
            </a:extLst>
          </p:cNvPr>
          <p:cNvSpPr txBox="1"/>
          <p:nvPr/>
        </p:nvSpPr>
        <p:spPr>
          <a:xfrm>
            <a:off x="6371567" y="2576563"/>
            <a:ext cx="6643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227DE35-E58F-45D7-9978-DEF2200730E9}"/>
              </a:ext>
            </a:extLst>
          </p:cNvPr>
          <p:cNvSpPr txBox="1"/>
          <p:nvPr/>
        </p:nvSpPr>
        <p:spPr>
          <a:xfrm>
            <a:off x="8111407" y="2576563"/>
            <a:ext cx="6643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9DDDF8B-FF72-473D-AEBA-73F60A118897}"/>
              </a:ext>
            </a:extLst>
          </p:cNvPr>
          <p:cNvSpPr txBox="1"/>
          <p:nvPr/>
        </p:nvSpPr>
        <p:spPr>
          <a:xfrm>
            <a:off x="4541890" y="4388424"/>
            <a:ext cx="6643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047CB75-3F7E-457F-BDD1-9DCFF0239CD9}"/>
              </a:ext>
            </a:extLst>
          </p:cNvPr>
          <p:cNvSpPr txBox="1"/>
          <p:nvPr/>
        </p:nvSpPr>
        <p:spPr>
          <a:xfrm>
            <a:off x="6431076" y="4388424"/>
            <a:ext cx="6643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095F54CC-8132-40CB-ADC2-624F7BB9B34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1125" t="15047" r="4296" b="11342"/>
          <a:stretch/>
        </p:blipFill>
        <p:spPr>
          <a:xfrm>
            <a:off x="7297216" y="3201361"/>
            <a:ext cx="564315" cy="1102589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3FF04557-A3BD-4A49-83A4-962CCFEB0913}"/>
              </a:ext>
            </a:extLst>
          </p:cNvPr>
          <p:cNvSpPr txBox="1"/>
          <p:nvPr/>
        </p:nvSpPr>
        <p:spPr>
          <a:xfrm>
            <a:off x="7673245" y="4106985"/>
            <a:ext cx="241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0AC09FC-37DD-4ECF-B105-823C74D1F289}"/>
              </a:ext>
            </a:extLst>
          </p:cNvPr>
          <p:cNvSpPr txBox="1"/>
          <p:nvPr/>
        </p:nvSpPr>
        <p:spPr>
          <a:xfrm>
            <a:off x="7063122" y="4123182"/>
            <a:ext cx="514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3C4DF573-9686-41DC-8333-F9619B717C4D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7454" t="376" r="21361" b="-1"/>
          <a:stretch/>
        </p:blipFill>
        <p:spPr>
          <a:xfrm>
            <a:off x="7906138" y="3201361"/>
            <a:ext cx="512233" cy="1102589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FAAD0406-7623-4861-976B-70C436BE17A7}"/>
              </a:ext>
            </a:extLst>
          </p:cNvPr>
          <p:cNvSpPr txBox="1"/>
          <p:nvPr/>
        </p:nvSpPr>
        <p:spPr>
          <a:xfrm>
            <a:off x="8240384" y="4106985"/>
            <a:ext cx="241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1069929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</Words>
  <Application>Microsoft Office PowerPoint</Application>
  <PresentationFormat>Widescreen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 Zoller</dc:creator>
  <cp:lastModifiedBy>Stephen Zoller</cp:lastModifiedBy>
  <cp:revision>1</cp:revision>
  <dcterms:created xsi:type="dcterms:W3CDTF">2020-08-22T04:20:56Z</dcterms:created>
  <dcterms:modified xsi:type="dcterms:W3CDTF">2020-08-22T04:21:08Z</dcterms:modified>
</cp:coreProperties>
</file>